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  <Override PartName="/ppt/presentation.xml" ContentType="application/vnd.openxmlformats-officedocument.presentationml.presentation.main+xml"/>
  <Override PartName="/ppt/slideMasters/_rels/slideMaster2.xml.rels" ContentType="application/vnd.openxmlformats-package.relationships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_rels/presentation.xml.rels" ContentType="application/vnd.openxmlformats-package.relationships+xml"/>
  <Override PartName="/ppt/slideLayouts/slideLayout13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_rels/slideLayout22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6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20.xml.rels" ContentType="application/vnd.openxmlformats-package.relationships+xml"/>
  <Override PartName="/ppt/slideLayouts/slideLayout6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22.xml" ContentType="application/vnd.openxmlformats-officedocument.presentationml.slideLayout+xml"/>
  <Override PartName="/ppt/media/image10.tif" ContentType="image/tiff"/>
  <Override PartName="/ppt/media/image9.tif" ContentType="image/tiff"/>
  <Override PartName="/ppt/media/image8.tif" ContentType="image/tiff"/>
  <Override PartName="/ppt/media/image6.jpeg" ContentType="image/jpeg"/>
  <Override PartName="/ppt/media/image12.tif" ContentType="image/tiff"/>
  <Override PartName="/ppt/media/image1.png" ContentType="image/png"/>
  <Override PartName="/ppt/media/image7.tif" ContentType="image/tiff"/>
  <Override PartName="/ppt/media/image20.jpeg" ContentType="image/jpeg"/>
  <Override PartName="/ppt/media/image19.tif" ContentType="image/tiff"/>
  <Override PartName="/ppt/media/image18.tif" ContentType="image/tiff"/>
  <Override PartName="/ppt/media/image16.tif" ContentType="image/tiff"/>
  <Override PartName="/ppt/media/image2.png" ContentType="image/png"/>
  <Override PartName="/ppt/media/image14.png" ContentType="image/png"/>
  <Override PartName="/ppt/media/image17.jpeg" ContentType="image/jpeg"/>
  <Override PartName="/ppt/media/image3.png" ContentType="image/png"/>
  <Override PartName="/ppt/media/image4.png" ContentType="image/png"/>
  <Override PartName="/ppt/media/image15.tif" ContentType="image/tiff"/>
  <Override PartName="/ppt/media/image5.jpeg" ContentType="image/jpeg"/>
  <Override PartName="/ppt/media/image11.tif" ContentType="image/tiff"/>
  <Override PartName="/ppt/media/image13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custom-properties" Target="docProps/custom.xml"/><Relationship Id="rId4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</p:sldMasterIdLst>
  <p:sldIdLst>
    <p:sldId id="256" r:id="rId4"/>
    <p:sldId id="257" r:id="rId5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" Target="slides/slide1.xml"/><Relationship Id="rId5" Type="http://schemas.openxmlformats.org/officeDocument/2006/relationships/slide" Target="slides/slide2.xml"/><Relationship Id="rId6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4C4A93F-8CF0-4C0C-8B5B-3C0FF05F7A0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498BA-229D-48E8-8E38-BDDFF9E6C9E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0819FB6-C05E-4A35-8636-07DB92CE7F86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C3C43F-5BE8-4FEE-871D-75D7C8B842D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1F3CA95D-4170-4C08-BA4D-8DDE01F61B2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25523BA-B04E-410F-A9FF-2142385F7F1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35B9AE7-860C-49EE-962C-0296E9D86FE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E14E00F-4D7D-43D4-8870-333A0BBE8CDF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A07392EF-2833-4DA5-A82D-48B323FA50E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D113F8-139C-421C-A98E-2BA68F5DF7C6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E5E6CEB3-EC5C-4CA2-8FE9-63A7BCC9E5C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4E168C-20C5-4EAA-B113-10AABC5BF05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CDBCAC85-85AC-47EE-9671-307E81D55A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3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D626B9DF-1DA5-40DB-9C13-D9D066B90B0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3631E284-4A32-4CD0-8D08-4BB311C41BD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1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2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3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4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F4B136E7-FDC6-4EC5-BE2C-BEA863CB463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7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8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9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0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1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5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6"/>
          </p:nvPr>
        </p:nvSpPr>
        <p:spPr/>
        <p:txBody>
          <a:bodyPr/>
          <a:p>
            <a:fld id="{9D19F96A-7B49-4DCC-8501-2209345792BE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4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48CEF3-91C8-419D-B92B-65F0704FA0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07DF32-072B-4896-B69F-9945D06F075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86B2D60-E993-4869-A86D-963F2B35826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451"/>
              </a:spcBef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502152-5051-46A0-B105-3A910CE7061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682318C-929F-454D-98E0-0916DB1F43E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E03FA59-1C45-45A1-A552-8AA4AFD449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451"/>
              </a:spcBef>
              <a:buNone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F21532-69B2-4F1B-8B95-A8AC6E08BF81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3427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6858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028880" indent="-34308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marL="216000"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9A622F3F-3E66-4AC4-82F0-F12BF72EB3D5}" type="slidenum">
              <a:rPr b="0" lang="zh-CN" sz="10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33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33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57040" indent="-25704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1" marL="343080" indent="34272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2" marL="685800">
              <a:spcBef>
                <a:spcPts val="451"/>
              </a:spcBef>
              <a:buClr>
                <a:srgbClr val="000000"/>
              </a:buClr>
              <a:buFont typeface="Arial"/>
              <a:buChar char="•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3" marL="1028880" indent="-343080">
              <a:spcBef>
                <a:spcPts val="451"/>
              </a:spcBef>
              <a:buClr>
                <a:srgbClr val="000000"/>
              </a:buClr>
              <a:buFont typeface="Arial"/>
              <a:buChar char="–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4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5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  <a:p>
            <a:pPr lvl="6" marL="1371600" indent="-685800">
              <a:spcBef>
                <a:spcPts val="451"/>
              </a:spcBef>
              <a:buClr>
                <a:srgbClr val="000000"/>
              </a:buClr>
              <a:buFont typeface="Arial"/>
              <a:buChar char="»"/>
              <a:tabLst>
                <a:tab algn="l" pos="685800"/>
                <a:tab algn="l" pos="1371600"/>
                <a:tab algn="l" pos="2057400"/>
                <a:tab algn="l" pos="2743200"/>
                <a:tab algn="l" pos="3429000"/>
                <a:tab algn="l" pos="4114800"/>
                <a:tab algn="l" pos="4800600"/>
                <a:tab algn="l" pos="5486400"/>
                <a:tab algn="l" pos="6172200"/>
                <a:tab algn="l" pos="6858000"/>
                <a:tab algn="l" pos="7543800"/>
                <a:tab algn="l" pos="8229600"/>
                <a:tab algn="l" pos="8915400"/>
                <a:tab algn="l" pos="9601200"/>
                <a:tab algn="l" pos="102870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3"/>
          <p:cNvSpPr>
            <a:spLocks noGrp="1"/>
          </p:cNvSpPr>
          <p:nvPr>
            <p:ph type="dt" idx="4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4"/>
          <p:cNvSpPr>
            <a:spLocks noGrp="1"/>
          </p:cNvSpPr>
          <p:nvPr>
            <p:ph type="ftr" idx="5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PlaceHolder 5"/>
          <p:cNvSpPr>
            <a:spLocks noGrp="1"/>
          </p:cNvSpPr>
          <p:nvPr>
            <p:ph type="sldNum" idx="6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zh-CN" sz="1000" spc="-1" strike="noStrike">
                <a:solidFill>
                  <a:srgbClr val="000000"/>
                </a:solidFill>
                <a:latin typeface="Arial"/>
                <a:ea typeface="宋体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5EFE966-FE80-4295-A9C7-BDAB5F4901EB}" type="slidenum">
              <a:rPr b="0" lang="zh-CN" sz="1000" spc="-1" strike="noStrike">
                <a:solidFill>
                  <a:srgbClr val="000000"/>
                </a:solidFill>
                <a:latin typeface="Arial"/>
                <a:ea typeface="宋体"/>
              </a:rPr>
              <a:t>&lt;number&gt;</a:t>
            </a:fld>
            <a:endParaRPr b="0" lang="en-US" sz="10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tif"/><Relationship Id="rId8" Type="http://schemas.openxmlformats.org/officeDocument/2006/relationships/image" Target="../media/image8.tif"/><Relationship Id="rId9" Type="http://schemas.openxmlformats.org/officeDocument/2006/relationships/image" Target="../media/image9.tif"/><Relationship Id="rId10" Type="http://schemas.openxmlformats.org/officeDocument/2006/relationships/image" Target="../media/image10.tif"/><Relationship Id="rId11" Type="http://schemas.openxmlformats.org/officeDocument/2006/relationships/image" Target="../media/image11.tif"/><Relationship Id="rId12" Type="http://schemas.openxmlformats.org/officeDocument/2006/relationships/image" Target="../media/image12.tif"/><Relationship Id="rId13" Type="http://schemas.openxmlformats.org/officeDocument/2006/relationships/slideLayout" Target="../slideLayouts/slideLayout13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3.png"/><Relationship Id="rId2" Type="http://schemas.openxmlformats.org/officeDocument/2006/relationships/image" Target="../media/image14.png"/><Relationship Id="rId3" Type="http://schemas.openxmlformats.org/officeDocument/2006/relationships/image" Target="../media/image15.tif"/><Relationship Id="rId4" Type="http://schemas.openxmlformats.org/officeDocument/2006/relationships/image" Target="../media/image16.tif"/><Relationship Id="rId5" Type="http://schemas.openxmlformats.org/officeDocument/2006/relationships/image" Target="../media/image17.jpeg"/><Relationship Id="rId6" Type="http://schemas.openxmlformats.org/officeDocument/2006/relationships/image" Target="../media/image18.tif"/><Relationship Id="rId7" Type="http://schemas.openxmlformats.org/officeDocument/2006/relationships/image" Target="../media/image19.tif"/><Relationship Id="rId8" Type="http://schemas.openxmlformats.org/officeDocument/2006/relationships/image" Target="../media/image20.jpeg"/><Relationship Id="rId9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文本框 14"/>
          <p:cNvSpPr/>
          <p:nvPr/>
        </p:nvSpPr>
        <p:spPr>
          <a:xfrm>
            <a:off x="78840" y="47520"/>
            <a:ext cx="116964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Figure 2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3" name="组合 1"/>
          <p:cNvGrpSpPr/>
          <p:nvPr/>
        </p:nvGrpSpPr>
        <p:grpSpPr>
          <a:xfrm>
            <a:off x="160200" y="841320"/>
            <a:ext cx="3200400" cy="1377720"/>
            <a:chOff x="160200" y="841320"/>
            <a:chExt cx="3200400" cy="1377720"/>
          </a:xfrm>
        </p:grpSpPr>
        <p:grpSp>
          <p:nvGrpSpPr>
            <p:cNvPr id="84" name="组合 3"/>
            <p:cNvGrpSpPr/>
            <p:nvPr/>
          </p:nvGrpSpPr>
          <p:grpSpPr>
            <a:xfrm>
              <a:off x="1134360" y="841320"/>
              <a:ext cx="2226240" cy="1377720"/>
              <a:chOff x="1134360" y="841320"/>
              <a:chExt cx="2226240" cy="1377720"/>
            </a:xfrm>
          </p:grpSpPr>
          <p:grpSp>
            <p:nvGrpSpPr>
              <p:cNvPr id="85" name="组合 17"/>
              <p:cNvGrpSpPr/>
              <p:nvPr/>
            </p:nvGrpSpPr>
            <p:grpSpPr>
              <a:xfrm>
                <a:off x="1134360" y="841320"/>
                <a:ext cx="2226240" cy="276480"/>
                <a:chOff x="1134360" y="841320"/>
                <a:chExt cx="2226240" cy="276480"/>
              </a:xfrm>
            </p:grpSpPr>
            <p:sp>
              <p:nvSpPr>
                <p:cNvPr id="86" name="文本框 1"/>
                <p:cNvSpPr/>
                <p:nvPr/>
              </p:nvSpPr>
              <p:spPr>
                <a:xfrm>
                  <a:off x="1134360" y="841320"/>
                  <a:ext cx="83556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Control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7" name="文本框 2"/>
                <p:cNvSpPr/>
                <p:nvPr/>
              </p:nvSpPr>
              <p:spPr>
                <a:xfrm>
                  <a:off x="1969560" y="841320"/>
                  <a:ext cx="61560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DKD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88" name="文本框 3"/>
                <p:cNvSpPr/>
                <p:nvPr/>
              </p:nvSpPr>
              <p:spPr>
                <a:xfrm>
                  <a:off x="2585520" y="841320"/>
                  <a:ext cx="775080" cy="2764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200" spc="-1" strike="noStrike">
                      <a:solidFill>
                        <a:srgbClr val="000000"/>
                      </a:solidFill>
                      <a:latin typeface="Arial"/>
                    </a:rPr>
                    <a:t>QRXZF</a:t>
                  </a:r>
                  <a:endParaRPr b="0" lang="en-US" sz="12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pic>
            <p:nvPicPr>
              <p:cNvPr id="89" name="图片 10" descr=""/>
              <p:cNvPicPr/>
              <p:nvPr/>
            </p:nvPicPr>
            <p:blipFill>
              <a:blip r:embed="rId1"/>
              <a:stretch/>
            </p:blipFill>
            <p:spPr>
              <a:xfrm>
                <a:off x="1218240" y="1703880"/>
                <a:ext cx="1998000" cy="215640"/>
              </a:xfrm>
              <a:prstGeom prst="rect">
                <a:avLst/>
              </a:prstGeom>
              <a:ln w="0">
                <a:noFill/>
              </a:ln>
            </p:spPr>
          </p:pic>
          <p:grpSp>
            <p:nvGrpSpPr>
              <p:cNvPr id="90" name="组合 1"/>
              <p:cNvGrpSpPr/>
              <p:nvPr/>
            </p:nvGrpSpPr>
            <p:grpSpPr>
              <a:xfrm>
                <a:off x="1218240" y="1087200"/>
                <a:ext cx="1996920" cy="1131840"/>
                <a:chOff x="1218240" y="1087200"/>
                <a:chExt cx="1996920" cy="1131840"/>
              </a:xfrm>
            </p:grpSpPr>
            <p:pic>
              <p:nvPicPr>
                <p:cNvPr id="91" name="图片 4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1218240" y="1401120"/>
                  <a:ext cx="1996920" cy="213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2" name="图片 5" descr=""/>
                <p:cNvPicPr/>
                <p:nvPr/>
              </p:nvPicPr>
              <p:blipFill>
                <a:blip r:embed="rId3"/>
                <a:stretch/>
              </p:blipFill>
              <p:spPr>
                <a:xfrm>
                  <a:off x="1218600" y="1087200"/>
                  <a:ext cx="1996560" cy="21312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93" name="图片 11" descr=""/>
                <p:cNvPicPr/>
                <p:nvPr/>
              </p:nvPicPr>
              <p:blipFill>
                <a:blip r:embed="rId4"/>
                <a:stretch/>
              </p:blipFill>
              <p:spPr>
                <a:xfrm>
                  <a:off x="1218240" y="2005200"/>
                  <a:ext cx="1996920" cy="21384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</p:grpSp>
        <p:grpSp>
          <p:nvGrpSpPr>
            <p:cNvPr id="94" name="组合 16"/>
            <p:cNvGrpSpPr/>
            <p:nvPr/>
          </p:nvGrpSpPr>
          <p:grpSpPr>
            <a:xfrm>
              <a:off x="160200" y="1086840"/>
              <a:ext cx="1199880" cy="1100160"/>
              <a:chOff x="160200" y="1086840"/>
              <a:chExt cx="1199880" cy="1100160"/>
            </a:xfrm>
          </p:grpSpPr>
          <p:sp>
            <p:nvSpPr>
              <p:cNvPr id="95" name="文本框 5"/>
              <p:cNvSpPr/>
              <p:nvPr/>
            </p:nvSpPr>
            <p:spPr>
              <a:xfrm>
                <a:off x="557640" y="1910520"/>
                <a:ext cx="7653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β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" name="文本框 13"/>
              <p:cNvSpPr/>
              <p:nvPr/>
            </p:nvSpPr>
            <p:spPr>
              <a:xfrm>
                <a:off x="657360" y="1086840"/>
                <a:ext cx="7027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TLR4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文本框 14"/>
              <p:cNvSpPr/>
              <p:nvPr/>
            </p:nvSpPr>
            <p:spPr>
              <a:xfrm>
                <a:off x="160200" y="1322280"/>
                <a:ext cx="11185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F-κB p-p6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" name="文本框 15"/>
              <p:cNvSpPr/>
              <p:nvPr/>
            </p:nvSpPr>
            <p:spPr>
              <a:xfrm>
                <a:off x="311400" y="1621080"/>
                <a:ext cx="100728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NF-κB p65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  <p:grpSp>
        <p:nvGrpSpPr>
          <p:cNvPr id="99" name="组合 28"/>
          <p:cNvGrpSpPr/>
          <p:nvPr/>
        </p:nvGrpSpPr>
        <p:grpSpPr>
          <a:xfrm>
            <a:off x="41400" y="2927520"/>
            <a:ext cx="6753240" cy="3401280"/>
            <a:chOff x="41400" y="2927520"/>
            <a:chExt cx="6753240" cy="3401280"/>
          </a:xfrm>
        </p:grpSpPr>
        <p:pic>
          <p:nvPicPr>
            <p:cNvPr id="100" name="图片 6" descr="TRL4"/>
            <p:cNvPicPr/>
            <p:nvPr/>
          </p:nvPicPr>
          <p:blipFill>
            <a:blip r:embed="rId5"/>
            <a:srcRect l="3852" t="20430" r="13485" b="36057"/>
            <a:stretch/>
          </p:blipFill>
          <p:spPr>
            <a:xfrm>
              <a:off x="4737240" y="3118680"/>
              <a:ext cx="2057400" cy="90252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101" name="图片 15" descr="P65 and P-P65"/>
            <p:cNvPicPr/>
            <p:nvPr/>
          </p:nvPicPr>
          <p:blipFill>
            <a:blip r:embed="rId6"/>
            <a:srcRect l="5391" t="12819" r="6675" b="10560"/>
            <a:stretch/>
          </p:blipFill>
          <p:spPr>
            <a:xfrm>
              <a:off x="4592520" y="4266360"/>
              <a:ext cx="2202120" cy="1816560"/>
            </a:xfrm>
            <a:prstGeom prst="rect">
              <a:avLst/>
            </a:prstGeom>
            <a:ln w="0">
              <a:noFill/>
            </a:ln>
          </p:spPr>
        </p:pic>
        <p:grpSp>
          <p:nvGrpSpPr>
            <p:cNvPr id="102" name="组合 27"/>
            <p:cNvGrpSpPr/>
            <p:nvPr/>
          </p:nvGrpSpPr>
          <p:grpSpPr>
            <a:xfrm>
              <a:off x="41400" y="2927520"/>
              <a:ext cx="4763880" cy="3401280"/>
              <a:chOff x="41400" y="2927520"/>
              <a:chExt cx="4763880" cy="3401280"/>
            </a:xfrm>
          </p:grpSpPr>
          <p:grpSp>
            <p:nvGrpSpPr>
              <p:cNvPr id="103" name="组合 7"/>
              <p:cNvGrpSpPr/>
              <p:nvPr/>
            </p:nvGrpSpPr>
            <p:grpSpPr>
              <a:xfrm>
                <a:off x="753480" y="3172680"/>
                <a:ext cx="3837960" cy="715320"/>
                <a:chOff x="753480" y="3172680"/>
                <a:chExt cx="3837960" cy="715320"/>
              </a:xfrm>
            </p:grpSpPr>
            <p:pic>
              <p:nvPicPr>
                <p:cNvPr id="104" name="图片 4" descr="TLR4"/>
                <p:cNvPicPr/>
                <p:nvPr/>
              </p:nvPicPr>
              <p:blipFill>
                <a:blip r:embed="rId7"/>
                <a:stretch/>
              </p:blipFill>
              <p:spPr>
                <a:xfrm>
                  <a:off x="753480" y="3172680"/>
                  <a:ext cx="3837240" cy="28296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5" name="图片 5" descr="β-tubulin"/>
                <p:cNvPicPr/>
                <p:nvPr/>
              </p:nvPicPr>
              <p:blipFill>
                <a:blip r:embed="rId8"/>
                <a:stretch/>
              </p:blipFill>
              <p:spPr>
                <a:xfrm>
                  <a:off x="754200" y="3560040"/>
                  <a:ext cx="3837240" cy="32796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106" name="组合 13"/>
              <p:cNvGrpSpPr/>
              <p:nvPr/>
            </p:nvGrpSpPr>
            <p:grpSpPr>
              <a:xfrm>
                <a:off x="753480" y="4381920"/>
                <a:ext cx="3845160" cy="770760"/>
                <a:chOff x="753480" y="4381920"/>
                <a:chExt cx="3845160" cy="770760"/>
              </a:xfrm>
            </p:grpSpPr>
            <p:pic>
              <p:nvPicPr>
                <p:cNvPr id="107" name="图片 9" descr="p-P65"/>
                <p:cNvPicPr/>
                <p:nvPr/>
              </p:nvPicPr>
              <p:blipFill>
                <a:blip r:embed="rId9"/>
                <a:stretch/>
              </p:blipFill>
              <p:spPr>
                <a:xfrm>
                  <a:off x="753480" y="4381920"/>
                  <a:ext cx="3837240" cy="3276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08" name="图片 11" descr="β-actin - p-P65"/>
                <p:cNvPicPr/>
                <p:nvPr/>
              </p:nvPicPr>
              <p:blipFill>
                <a:blip r:embed="rId10"/>
                <a:stretch/>
              </p:blipFill>
              <p:spPr>
                <a:xfrm>
                  <a:off x="761400" y="4825080"/>
                  <a:ext cx="3837240" cy="3276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109" name="组合 14"/>
              <p:cNvGrpSpPr/>
              <p:nvPr/>
            </p:nvGrpSpPr>
            <p:grpSpPr>
              <a:xfrm>
                <a:off x="712440" y="5578560"/>
                <a:ext cx="3845520" cy="750240"/>
                <a:chOff x="712440" y="5578560"/>
                <a:chExt cx="3845520" cy="750240"/>
              </a:xfrm>
            </p:grpSpPr>
            <p:pic>
              <p:nvPicPr>
                <p:cNvPr id="110" name="图片 10" descr="p65"/>
                <p:cNvPicPr/>
                <p:nvPr/>
              </p:nvPicPr>
              <p:blipFill>
                <a:blip r:embed="rId11"/>
                <a:stretch/>
              </p:blipFill>
              <p:spPr>
                <a:xfrm>
                  <a:off x="720720" y="5578560"/>
                  <a:ext cx="3837240" cy="3276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11" name="图片 12" descr="β-actin - p65"/>
                <p:cNvPicPr/>
                <p:nvPr/>
              </p:nvPicPr>
              <p:blipFill>
                <a:blip r:embed="rId12"/>
                <a:stretch/>
              </p:blipFill>
              <p:spPr>
                <a:xfrm>
                  <a:off x="712440" y="6001200"/>
                  <a:ext cx="3837240" cy="3276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grpSp>
            <p:nvGrpSpPr>
              <p:cNvPr id="112" name="组合 27"/>
              <p:cNvGrpSpPr/>
              <p:nvPr/>
            </p:nvGrpSpPr>
            <p:grpSpPr>
              <a:xfrm>
                <a:off x="41400" y="3148920"/>
                <a:ext cx="964800" cy="3146400"/>
                <a:chOff x="41400" y="3148920"/>
                <a:chExt cx="964800" cy="3146400"/>
              </a:xfrm>
            </p:grpSpPr>
            <p:sp>
              <p:nvSpPr>
                <p:cNvPr id="113" name="文本框 16"/>
                <p:cNvSpPr/>
                <p:nvPr/>
              </p:nvSpPr>
              <p:spPr>
                <a:xfrm>
                  <a:off x="207360" y="3148920"/>
                  <a:ext cx="7218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TLR4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4" name="文本框 17"/>
                <p:cNvSpPr/>
                <p:nvPr/>
              </p:nvSpPr>
              <p:spPr>
                <a:xfrm>
                  <a:off x="60480" y="3559680"/>
                  <a:ext cx="93636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β-actin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5" name="文本框 20"/>
                <p:cNvSpPr/>
                <p:nvPr/>
              </p:nvSpPr>
              <p:spPr>
                <a:xfrm>
                  <a:off x="41400" y="5988240"/>
                  <a:ext cx="9648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β-actin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6" name="文本框 21"/>
                <p:cNvSpPr/>
                <p:nvPr/>
              </p:nvSpPr>
              <p:spPr>
                <a:xfrm>
                  <a:off x="52560" y="4825080"/>
                  <a:ext cx="95364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β-actin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7" name="文本框 23"/>
                <p:cNvSpPr/>
                <p:nvPr/>
              </p:nvSpPr>
              <p:spPr>
                <a:xfrm>
                  <a:off x="128520" y="4418640"/>
                  <a:ext cx="85680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P-P65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118" name="文本框 24"/>
                <p:cNvSpPr/>
                <p:nvPr/>
              </p:nvSpPr>
              <p:spPr>
                <a:xfrm>
                  <a:off x="253080" y="5589360"/>
                  <a:ext cx="743760" cy="307080"/>
                </a:xfrm>
                <a:prstGeom prst="rect">
                  <a:avLst/>
                </a:prstGeom>
                <a:noFill/>
                <a:ln w="0">
                  <a:noFill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spAutoFit/>
                </a:bodyPr>
                <a:p>
                  <a:pPr>
                    <a:lnSpc>
                      <a:spcPct val="100000"/>
                    </a:lnSpc>
                    <a:tabLst>
                      <a:tab algn="l" pos="0"/>
                      <a:tab algn="l" pos="914400"/>
                      <a:tab algn="l" pos="1828800"/>
                      <a:tab algn="l" pos="2743200"/>
                      <a:tab algn="l" pos="3657600"/>
                      <a:tab algn="l" pos="4572000"/>
                      <a:tab algn="l" pos="5486400"/>
                      <a:tab algn="l" pos="6400800"/>
                      <a:tab algn="l" pos="7315200"/>
                      <a:tab algn="l" pos="8229600"/>
                      <a:tab algn="l" pos="9144000"/>
                      <a:tab algn="l" pos="10058400"/>
                    </a:tabLst>
                  </a:pPr>
                  <a:r>
                    <a:rPr b="1" lang="en-US" sz="1400" spc="-1" strike="noStrike">
                      <a:solidFill>
                        <a:srgbClr val="000000"/>
                      </a:solidFill>
                      <a:latin typeface="Arial"/>
                    </a:rPr>
                    <a:t>P65</a:t>
                  </a:r>
                  <a:endParaRPr b="0" lang="en-US" sz="14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119" name="组合 46"/>
              <p:cNvGrpSpPr/>
              <p:nvPr/>
            </p:nvGrpSpPr>
            <p:grpSpPr>
              <a:xfrm>
                <a:off x="558000" y="4136760"/>
                <a:ext cx="4147560" cy="246240"/>
                <a:chOff x="558000" y="4136760"/>
                <a:chExt cx="4147560" cy="246240"/>
              </a:xfrm>
            </p:grpSpPr>
            <p:grpSp>
              <p:nvGrpSpPr>
                <p:cNvPr id="120" name="组合 37"/>
                <p:cNvGrpSpPr/>
                <p:nvPr/>
              </p:nvGrpSpPr>
              <p:grpSpPr>
                <a:xfrm>
                  <a:off x="558000" y="4136760"/>
                  <a:ext cx="1507320" cy="246240"/>
                  <a:chOff x="558000" y="4136760"/>
                  <a:chExt cx="1507320" cy="246240"/>
                </a:xfrm>
              </p:grpSpPr>
              <p:sp>
                <p:nvSpPr>
                  <p:cNvPr id="121" name="文本框 29"/>
                  <p:cNvSpPr/>
                  <p:nvPr/>
                </p:nvSpPr>
                <p:spPr>
                  <a:xfrm>
                    <a:off x="558000" y="4136760"/>
                    <a:ext cx="5331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2" name="文本框 33"/>
                  <p:cNvSpPr/>
                  <p:nvPr/>
                </p:nvSpPr>
                <p:spPr>
                  <a:xfrm>
                    <a:off x="930600" y="4136760"/>
                    <a:ext cx="572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3" name="文本框 34"/>
                  <p:cNvSpPr/>
                  <p:nvPr/>
                </p:nvSpPr>
                <p:spPr>
                  <a:xfrm>
                    <a:off x="1358640" y="4136760"/>
                    <a:ext cx="7066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24" name="组合 38"/>
                <p:cNvGrpSpPr/>
                <p:nvPr/>
              </p:nvGrpSpPr>
              <p:grpSpPr>
                <a:xfrm>
                  <a:off x="1869840" y="4136760"/>
                  <a:ext cx="1518120" cy="246240"/>
                  <a:chOff x="1869840" y="4136760"/>
                  <a:chExt cx="1518120" cy="246240"/>
                </a:xfrm>
              </p:grpSpPr>
              <p:sp>
                <p:nvSpPr>
                  <p:cNvPr id="125" name="文本框 39"/>
                  <p:cNvSpPr/>
                  <p:nvPr/>
                </p:nvSpPr>
                <p:spPr>
                  <a:xfrm>
                    <a:off x="1869840" y="4136760"/>
                    <a:ext cx="5371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6" name="文本框 40"/>
                  <p:cNvSpPr/>
                  <p:nvPr/>
                </p:nvSpPr>
                <p:spPr>
                  <a:xfrm>
                    <a:off x="2257200" y="4136760"/>
                    <a:ext cx="563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27" name="文本框 41"/>
                  <p:cNvSpPr/>
                  <p:nvPr/>
                </p:nvSpPr>
                <p:spPr>
                  <a:xfrm>
                    <a:off x="2676240" y="4136760"/>
                    <a:ext cx="7117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28" name="组合 42"/>
                <p:cNvGrpSpPr/>
                <p:nvPr/>
              </p:nvGrpSpPr>
              <p:grpSpPr>
                <a:xfrm>
                  <a:off x="3188880" y="4136760"/>
                  <a:ext cx="1516680" cy="246240"/>
                  <a:chOff x="3188880" y="4136760"/>
                  <a:chExt cx="1516680" cy="246240"/>
                </a:xfrm>
              </p:grpSpPr>
              <p:sp>
                <p:nvSpPr>
                  <p:cNvPr id="129" name="文本框 43"/>
                  <p:cNvSpPr/>
                  <p:nvPr/>
                </p:nvSpPr>
                <p:spPr>
                  <a:xfrm>
                    <a:off x="3188880" y="4136760"/>
                    <a:ext cx="5364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0" name="文本框 44"/>
                  <p:cNvSpPr/>
                  <p:nvPr/>
                </p:nvSpPr>
                <p:spPr>
                  <a:xfrm>
                    <a:off x="3544200" y="4136760"/>
                    <a:ext cx="5601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1" name="文本框 45"/>
                  <p:cNvSpPr/>
                  <p:nvPr/>
                </p:nvSpPr>
                <p:spPr>
                  <a:xfrm>
                    <a:off x="3994560" y="4136760"/>
                    <a:ext cx="7110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32" name="组合 46"/>
              <p:cNvGrpSpPr/>
              <p:nvPr/>
            </p:nvGrpSpPr>
            <p:grpSpPr>
              <a:xfrm>
                <a:off x="657720" y="2927520"/>
                <a:ext cx="4147560" cy="246240"/>
                <a:chOff x="657720" y="2927520"/>
                <a:chExt cx="4147560" cy="246240"/>
              </a:xfrm>
            </p:grpSpPr>
            <p:grpSp>
              <p:nvGrpSpPr>
                <p:cNvPr id="133" name="组合 37"/>
                <p:cNvGrpSpPr/>
                <p:nvPr/>
              </p:nvGrpSpPr>
              <p:grpSpPr>
                <a:xfrm>
                  <a:off x="657720" y="2927520"/>
                  <a:ext cx="1507320" cy="246240"/>
                  <a:chOff x="657720" y="2927520"/>
                  <a:chExt cx="1507320" cy="246240"/>
                </a:xfrm>
              </p:grpSpPr>
              <p:sp>
                <p:nvSpPr>
                  <p:cNvPr id="134" name="文本框 29"/>
                  <p:cNvSpPr/>
                  <p:nvPr/>
                </p:nvSpPr>
                <p:spPr>
                  <a:xfrm>
                    <a:off x="657720" y="2927520"/>
                    <a:ext cx="5331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5" name="文本框 33"/>
                  <p:cNvSpPr/>
                  <p:nvPr/>
                </p:nvSpPr>
                <p:spPr>
                  <a:xfrm>
                    <a:off x="1030320" y="2927520"/>
                    <a:ext cx="572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6" name="文本框 34"/>
                  <p:cNvSpPr/>
                  <p:nvPr/>
                </p:nvSpPr>
                <p:spPr>
                  <a:xfrm>
                    <a:off x="1458360" y="2927520"/>
                    <a:ext cx="7066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37" name="组合 38"/>
                <p:cNvGrpSpPr/>
                <p:nvPr/>
              </p:nvGrpSpPr>
              <p:grpSpPr>
                <a:xfrm>
                  <a:off x="1969560" y="2927520"/>
                  <a:ext cx="1518120" cy="246240"/>
                  <a:chOff x="1969560" y="2927520"/>
                  <a:chExt cx="1518120" cy="246240"/>
                </a:xfrm>
              </p:grpSpPr>
              <p:sp>
                <p:nvSpPr>
                  <p:cNvPr id="138" name="文本框 39"/>
                  <p:cNvSpPr/>
                  <p:nvPr/>
                </p:nvSpPr>
                <p:spPr>
                  <a:xfrm>
                    <a:off x="1969560" y="2927520"/>
                    <a:ext cx="5371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39" name="文本框 40"/>
                  <p:cNvSpPr/>
                  <p:nvPr/>
                </p:nvSpPr>
                <p:spPr>
                  <a:xfrm>
                    <a:off x="2356920" y="2927520"/>
                    <a:ext cx="563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0" name="文本框 41"/>
                  <p:cNvSpPr/>
                  <p:nvPr/>
                </p:nvSpPr>
                <p:spPr>
                  <a:xfrm>
                    <a:off x="2775960" y="2927520"/>
                    <a:ext cx="7117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41" name="组合 42"/>
                <p:cNvGrpSpPr/>
                <p:nvPr/>
              </p:nvGrpSpPr>
              <p:grpSpPr>
                <a:xfrm>
                  <a:off x="3288600" y="2927520"/>
                  <a:ext cx="1516680" cy="246240"/>
                  <a:chOff x="3288600" y="2927520"/>
                  <a:chExt cx="1516680" cy="246240"/>
                </a:xfrm>
              </p:grpSpPr>
              <p:sp>
                <p:nvSpPr>
                  <p:cNvPr id="142" name="文本框 43"/>
                  <p:cNvSpPr/>
                  <p:nvPr/>
                </p:nvSpPr>
                <p:spPr>
                  <a:xfrm>
                    <a:off x="3288600" y="2927520"/>
                    <a:ext cx="5364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3" name="文本框 44"/>
                  <p:cNvSpPr/>
                  <p:nvPr/>
                </p:nvSpPr>
                <p:spPr>
                  <a:xfrm>
                    <a:off x="3643920" y="2927520"/>
                    <a:ext cx="5601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4" name="文本框 45"/>
                  <p:cNvSpPr/>
                  <p:nvPr/>
                </p:nvSpPr>
                <p:spPr>
                  <a:xfrm>
                    <a:off x="4094280" y="2927520"/>
                    <a:ext cx="7110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grpSp>
            <p:nvGrpSpPr>
              <p:cNvPr id="145" name="组合 46"/>
              <p:cNvGrpSpPr/>
              <p:nvPr/>
            </p:nvGrpSpPr>
            <p:grpSpPr>
              <a:xfrm>
                <a:off x="588600" y="5333400"/>
                <a:ext cx="4147560" cy="246240"/>
                <a:chOff x="588600" y="5333400"/>
                <a:chExt cx="4147560" cy="246240"/>
              </a:xfrm>
            </p:grpSpPr>
            <p:grpSp>
              <p:nvGrpSpPr>
                <p:cNvPr id="146" name="组合 37"/>
                <p:cNvGrpSpPr/>
                <p:nvPr/>
              </p:nvGrpSpPr>
              <p:grpSpPr>
                <a:xfrm>
                  <a:off x="588600" y="5333400"/>
                  <a:ext cx="1507320" cy="246240"/>
                  <a:chOff x="588600" y="5333400"/>
                  <a:chExt cx="1507320" cy="246240"/>
                </a:xfrm>
              </p:grpSpPr>
              <p:sp>
                <p:nvSpPr>
                  <p:cNvPr id="147" name="文本框 29"/>
                  <p:cNvSpPr/>
                  <p:nvPr/>
                </p:nvSpPr>
                <p:spPr>
                  <a:xfrm>
                    <a:off x="588600" y="5333400"/>
                    <a:ext cx="5331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8" name="文本框 33"/>
                  <p:cNvSpPr/>
                  <p:nvPr/>
                </p:nvSpPr>
                <p:spPr>
                  <a:xfrm>
                    <a:off x="961200" y="5333400"/>
                    <a:ext cx="572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49" name="文本框 34"/>
                  <p:cNvSpPr/>
                  <p:nvPr/>
                </p:nvSpPr>
                <p:spPr>
                  <a:xfrm>
                    <a:off x="1389240" y="5333400"/>
                    <a:ext cx="70668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1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50" name="组合 38"/>
                <p:cNvGrpSpPr/>
                <p:nvPr/>
              </p:nvGrpSpPr>
              <p:grpSpPr>
                <a:xfrm>
                  <a:off x="1900440" y="5333400"/>
                  <a:ext cx="1518120" cy="246240"/>
                  <a:chOff x="1900440" y="5333400"/>
                  <a:chExt cx="1518120" cy="246240"/>
                </a:xfrm>
              </p:grpSpPr>
              <p:sp>
                <p:nvSpPr>
                  <p:cNvPr id="151" name="文本框 39"/>
                  <p:cNvSpPr/>
                  <p:nvPr/>
                </p:nvSpPr>
                <p:spPr>
                  <a:xfrm>
                    <a:off x="1900440" y="5333400"/>
                    <a:ext cx="5371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2" name="文本框 40"/>
                  <p:cNvSpPr/>
                  <p:nvPr/>
                </p:nvSpPr>
                <p:spPr>
                  <a:xfrm>
                    <a:off x="2287800" y="5333400"/>
                    <a:ext cx="5637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3" name="文本框 41"/>
                  <p:cNvSpPr/>
                  <p:nvPr/>
                </p:nvSpPr>
                <p:spPr>
                  <a:xfrm>
                    <a:off x="2706840" y="5333400"/>
                    <a:ext cx="71172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2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54" name="组合 42"/>
                <p:cNvGrpSpPr/>
                <p:nvPr/>
              </p:nvGrpSpPr>
              <p:grpSpPr>
                <a:xfrm>
                  <a:off x="3219480" y="5333400"/>
                  <a:ext cx="1516680" cy="246240"/>
                  <a:chOff x="3219480" y="5333400"/>
                  <a:chExt cx="1516680" cy="246240"/>
                </a:xfrm>
              </p:grpSpPr>
              <p:sp>
                <p:nvSpPr>
                  <p:cNvPr id="155" name="文本框 43"/>
                  <p:cNvSpPr/>
                  <p:nvPr/>
                </p:nvSpPr>
                <p:spPr>
                  <a:xfrm>
                    <a:off x="3219480" y="5333400"/>
                    <a:ext cx="5364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Con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6" name="文本框 44"/>
                  <p:cNvSpPr/>
                  <p:nvPr/>
                </p:nvSpPr>
                <p:spPr>
                  <a:xfrm>
                    <a:off x="3574800" y="5333400"/>
                    <a:ext cx="56016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DKD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57" name="文本框 45"/>
                  <p:cNvSpPr/>
                  <p:nvPr/>
                </p:nvSpPr>
                <p:spPr>
                  <a:xfrm>
                    <a:off x="4025160" y="5333400"/>
                    <a:ext cx="711000" cy="24624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lnSpc>
                        <a:spcPct val="100000"/>
                      </a:lnSpc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000" spc="-1" strike="noStrike">
                        <a:solidFill>
                          <a:srgbClr val="000000"/>
                        </a:solidFill>
                        <a:latin typeface="Arial"/>
                      </a:rPr>
                      <a:t>QRXZF3</a:t>
                    </a:r>
                    <a:endParaRPr b="0" lang="en-US" sz="10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文本框 14"/>
          <p:cNvSpPr/>
          <p:nvPr/>
        </p:nvSpPr>
        <p:spPr>
          <a:xfrm>
            <a:off x="92160" y="109440"/>
            <a:ext cx="1245960" cy="3988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2000" spc="-1" strike="noStrike">
                <a:solidFill>
                  <a:srgbClr val="000000"/>
                </a:solidFill>
                <a:latin typeface="Arial"/>
              </a:rPr>
              <a:t>Figure 3</a:t>
            </a:r>
            <a:endParaRPr b="0" lang="en-US" sz="2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9" name="文本框 9"/>
          <p:cNvSpPr/>
          <p:nvPr/>
        </p:nvSpPr>
        <p:spPr>
          <a:xfrm>
            <a:off x="306360" y="6267600"/>
            <a:ext cx="291960" cy="36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60" name="组合 1"/>
          <p:cNvGrpSpPr/>
          <p:nvPr/>
        </p:nvGrpSpPr>
        <p:grpSpPr>
          <a:xfrm>
            <a:off x="-69840" y="1576440"/>
            <a:ext cx="6886080" cy="3755160"/>
            <a:chOff x="-69840" y="1576440"/>
            <a:chExt cx="6886080" cy="3755160"/>
          </a:xfrm>
        </p:grpSpPr>
        <p:grpSp>
          <p:nvGrpSpPr>
            <p:cNvPr id="161" name="组合 2"/>
            <p:cNvGrpSpPr/>
            <p:nvPr/>
          </p:nvGrpSpPr>
          <p:grpSpPr>
            <a:xfrm>
              <a:off x="163080" y="1576440"/>
              <a:ext cx="2698560" cy="772200"/>
              <a:chOff x="163080" y="1576440"/>
              <a:chExt cx="2698560" cy="772200"/>
            </a:xfrm>
          </p:grpSpPr>
          <p:grpSp>
            <p:nvGrpSpPr>
              <p:cNvPr id="162" name="组合 3"/>
              <p:cNvGrpSpPr/>
              <p:nvPr/>
            </p:nvGrpSpPr>
            <p:grpSpPr>
              <a:xfrm>
                <a:off x="787680" y="1789200"/>
                <a:ext cx="2000880" cy="558000"/>
                <a:chOff x="787680" y="1789200"/>
                <a:chExt cx="2000880" cy="558000"/>
              </a:xfrm>
            </p:grpSpPr>
            <p:pic>
              <p:nvPicPr>
                <p:cNvPr id="163" name="图片 1" descr=""/>
                <p:cNvPicPr/>
                <p:nvPr/>
              </p:nvPicPr>
              <p:blipFill>
                <a:blip r:embed="rId1"/>
                <a:stretch/>
              </p:blipFill>
              <p:spPr>
                <a:xfrm>
                  <a:off x="787680" y="1789200"/>
                  <a:ext cx="1995480" cy="250200"/>
                </a:xfrm>
                <a:prstGeom prst="rect">
                  <a:avLst/>
                </a:prstGeom>
                <a:ln w="0">
                  <a:noFill/>
                </a:ln>
              </p:spPr>
            </p:pic>
            <p:pic>
              <p:nvPicPr>
                <p:cNvPr id="164" name="图片 2" descr=""/>
                <p:cNvPicPr/>
                <p:nvPr/>
              </p:nvPicPr>
              <p:blipFill>
                <a:blip r:embed="rId2"/>
                <a:stretch/>
              </p:blipFill>
              <p:spPr>
                <a:xfrm>
                  <a:off x="790920" y="2097000"/>
                  <a:ext cx="1997640" cy="250200"/>
                </a:xfrm>
                <a:prstGeom prst="rect">
                  <a:avLst/>
                </a:prstGeom>
                <a:ln w="0">
                  <a:noFill/>
                </a:ln>
              </p:spPr>
            </p:pic>
          </p:grpSp>
          <p:sp>
            <p:nvSpPr>
              <p:cNvPr id="165" name="文本框 4"/>
              <p:cNvSpPr/>
              <p:nvPr/>
            </p:nvSpPr>
            <p:spPr>
              <a:xfrm>
                <a:off x="321840" y="1763280"/>
                <a:ext cx="6174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ZO-1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" name="文本框 5"/>
              <p:cNvSpPr/>
              <p:nvPr/>
            </p:nvSpPr>
            <p:spPr>
              <a:xfrm>
                <a:off x="163080" y="2072160"/>
                <a:ext cx="77616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β-actin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" name="文本框 1"/>
              <p:cNvSpPr/>
              <p:nvPr/>
            </p:nvSpPr>
            <p:spPr>
              <a:xfrm>
                <a:off x="787680" y="1576440"/>
                <a:ext cx="75420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Control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文本框 2"/>
              <p:cNvSpPr/>
              <p:nvPr/>
            </p:nvSpPr>
            <p:spPr>
              <a:xfrm>
                <a:off x="1527120" y="1576440"/>
                <a:ext cx="60732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DKD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" name="文本框 3"/>
              <p:cNvSpPr/>
              <p:nvPr/>
            </p:nvSpPr>
            <p:spPr>
              <a:xfrm>
                <a:off x="2134800" y="1576440"/>
                <a:ext cx="726840" cy="2764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200" spc="-1" strike="noStrike">
                    <a:solidFill>
                      <a:srgbClr val="000000"/>
                    </a:solidFill>
                    <a:latin typeface="Arial"/>
                  </a:rPr>
                  <a:t>QRXZF</a:t>
                </a:r>
                <a:endParaRPr b="0" lang="en-US" sz="12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70" name="组合 44"/>
            <p:cNvGrpSpPr/>
            <p:nvPr/>
          </p:nvGrpSpPr>
          <p:grpSpPr>
            <a:xfrm>
              <a:off x="-69840" y="2860200"/>
              <a:ext cx="6886080" cy="2471400"/>
              <a:chOff x="-69840" y="2860200"/>
              <a:chExt cx="6886080" cy="2471400"/>
            </a:xfrm>
          </p:grpSpPr>
          <p:grpSp>
            <p:nvGrpSpPr>
              <p:cNvPr id="171" name="组合 43"/>
              <p:cNvGrpSpPr/>
              <p:nvPr/>
            </p:nvGrpSpPr>
            <p:grpSpPr>
              <a:xfrm>
                <a:off x="-69840" y="2860200"/>
                <a:ext cx="6886080" cy="1119240"/>
                <a:chOff x="-69840" y="2860200"/>
                <a:chExt cx="6886080" cy="1119240"/>
              </a:xfrm>
            </p:grpSpPr>
            <p:grpSp>
              <p:nvGrpSpPr>
                <p:cNvPr id="172" name="组合 14"/>
                <p:cNvGrpSpPr/>
                <p:nvPr/>
              </p:nvGrpSpPr>
              <p:grpSpPr>
                <a:xfrm>
                  <a:off x="-69840" y="3079080"/>
                  <a:ext cx="817920" cy="822960"/>
                  <a:chOff x="-69840" y="3079080"/>
                  <a:chExt cx="817920" cy="822960"/>
                </a:xfrm>
              </p:grpSpPr>
              <p:sp>
                <p:nvSpPr>
                  <p:cNvPr id="173" name="文本框 4"/>
                  <p:cNvSpPr/>
                  <p:nvPr/>
                </p:nvSpPr>
                <p:spPr>
                  <a:xfrm>
                    <a:off x="51840" y="3079080"/>
                    <a:ext cx="61776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Arial"/>
                      </a:rPr>
                      <a:t>ZO-1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74" name="文本框 5"/>
                  <p:cNvSpPr/>
                  <p:nvPr/>
                </p:nvSpPr>
                <p:spPr>
                  <a:xfrm>
                    <a:off x="-69840" y="3594960"/>
                    <a:ext cx="81792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Arial"/>
                      </a:rPr>
                      <a:t>β-actin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75" name="组合 40"/>
                <p:cNvGrpSpPr/>
                <p:nvPr/>
              </p:nvGrpSpPr>
              <p:grpSpPr>
                <a:xfrm>
                  <a:off x="597960" y="2860200"/>
                  <a:ext cx="6218280" cy="1119240"/>
                  <a:chOff x="597960" y="2860200"/>
                  <a:chExt cx="6218280" cy="1119240"/>
                </a:xfrm>
              </p:grpSpPr>
              <p:grpSp>
                <p:nvGrpSpPr>
                  <p:cNvPr id="176" name="组合 5"/>
                  <p:cNvGrpSpPr/>
                  <p:nvPr/>
                </p:nvGrpSpPr>
                <p:grpSpPr>
                  <a:xfrm>
                    <a:off x="597960" y="3079080"/>
                    <a:ext cx="4174200" cy="796320"/>
                    <a:chOff x="597960" y="3079080"/>
                    <a:chExt cx="4174200" cy="796320"/>
                  </a:xfrm>
                </p:grpSpPr>
                <p:pic>
                  <p:nvPicPr>
                    <p:cNvPr id="177" name="图片 1" descr="ZO-1 （1）"/>
                    <p:cNvPicPr/>
                    <p:nvPr/>
                  </p:nvPicPr>
                  <p:blipFill>
                    <a:blip r:embed="rId3"/>
                    <a:stretch/>
                  </p:blipFill>
                  <p:spPr>
                    <a:xfrm>
                      <a:off x="597960" y="3079080"/>
                      <a:ext cx="4174200" cy="352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78" name="图片 3" descr="β-actin（1）"/>
                    <p:cNvPicPr/>
                    <p:nvPr/>
                  </p:nvPicPr>
                  <p:blipFill>
                    <a:blip r:embed="rId4"/>
                    <a:stretch/>
                  </p:blipFill>
                  <p:spPr>
                    <a:xfrm>
                      <a:off x="597960" y="3523320"/>
                      <a:ext cx="4174200" cy="3520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pic>
                <p:nvPicPr>
                  <p:cNvPr id="179" name="图片 7" descr="ZO-1（1）"/>
                  <p:cNvPicPr/>
                  <p:nvPr/>
                </p:nvPicPr>
                <p:blipFill>
                  <a:blip r:embed="rId5"/>
                  <a:srcRect l="5884" t="19162" r="13485" b="28152"/>
                  <a:stretch/>
                </p:blipFill>
                <p:spPr>
                  <a:xfrm>
                    <a:off x="4663440" y="2860200"/>
                    <a:ext cx="2152800" cy="111924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grpSp>
                <p:nvGrpSpPr>
                  <p:cNvPr id="180" name="组合 28"/>
                  <p:cNvGrpSpPr/>
                  <p:nvPr/>
                </p:nvGrpSpPr>
                <p:grpSpPr>
                  <a:xfrm>
                    <a:off x="598680" y="2860200"/>
                    <a:ext cx="4254120" cy="246240"/>
                    <a:chOff x="598680" y="2860200"/>
                    <a:chExt cx="4254120" cy="246240"/>
                  </a:xfrm>
                </p:grpSpPr>
                <p:grpSp>
                  <p:nvGrpSpPr>
                    <p:cNvPr id="181" name="组合 22"/>
                    <p:cNvGrpSpPr/>
                    <p:nvPr/>
                  </p:nvGrpSpPr>
                  <p:grpSpPr>
                    <a:xfrm>
                      <a:off x="598680" y="2860200"/>
                      <a:ext cx="2265480" cy="246240"/>
                      <a:chOff x="598680" y="2860200"/>
                      <a:chExt cx="2265480" cy="246240"/>
                    </a:xfrm>
                  </p:grpSpPr>
                  <p:sp>
                    <p:nvSpPr>
                      <p:cNvPr id="182" name="文本框 18"/>
                      <p:cNvSpPr/>
                      <p:nvPr/>
                    </p:nvSpPr>
                    <p:spPr>
                      <a:xfrm>
                        <a:off x="598680" y="2860200"/>
                        <a:ext cx="50652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Con1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83" name="文本框 19"/>
                      <p:cNvSpPr/>
                      <p:nvPr/>
                    </p:nvSpPr>
                    <p:spPr>
                      <a:xfrm>
                        <a:off x="1095120" y="2860200"/>
                        <a:ext cx="62460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DKD1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84" name="文本框 20"/>
                      <p:cNvSpPr/>
                      <p:nvPr/>
                    </p:nvSpPr>
                    <p:spPr>
                      <a:xfrm>
                        <a:off x="1447920" y="2860200"/>
                        <a:ext cx="76464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QRXZF1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85" name="文本框 21"/>
                      <p:cNvSpPr/>
                      <p:nvPr/>
                    </p:nvSpPr>
                    <p:spPr>
                      <a:xfrm>
                        <a:off x="1986840" y="2860200"/>
                        <a:ext cx="87732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Irbesartan1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grpSp>
                  <p:nvGrpSpPr>
                    <p:cNvPr id="186" name="组合 23"/>
                    <p:cNvGrpSpPr/>
                    <p:nvPr/>
                  </p:nvGrpSpPr>
                  <p:grpSpPr>
                    <a:xfrm>
                      <a:off x="2692440" y="2860200"/>
                      <a:ext cx="2160360" cy="246240"/>
                      <a:chOff x="2692440" y="2860200"/>
                      <a:chExt cx="2160360" cy="246240"/>
                    </a:xfrm>
                  </p:grpSpPr>
                  <p:sp>
                    <p:nvSpPr>
                      <p:cNvPr id="187" name="文本框 24"/>
                      <p:cNvSpPr/>
                      <p:nvPr/>
                    </p:nvSpPr>
                    <p:spPr>
                      <a:xfrm>
                        <a:off x="2692440" y="2860200"/>
                        <a:ext cx="53856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Con2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88" name="文本框 25"/>
                      <p:cNvSpPr/>
                      <p:nvPr/>
                    </p:nvSpPr>
                    <p:spPr>
                      <a:xfrm>
                        <a:off x="3106440" y="2860200"/>
                        <a:ext cx="59292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DKD2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89" name="文本框 26"/>
                      <p:cNvSpPr/>
                      <p:nvPr/>
                    </p:nvSpPr>
                    <p:spPr>
                      <a:xfrm>
                        <a:off x="3467880" y="2860200"/>
                        <a:ext cx="76680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QRXZF2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190" name="文本框 27"/>
                      <p:cNvSpPr/>
                      <p:nvPr/>
                    </p:nvSpPr>
                    <p:spPr>
                      <a:xfrm>
                        <a:off x="4019760" y="2860200"/>
                        <a:ext cx="83304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Irbesartan2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</p:grpSp>
          </p:grpSp>
          <p:grpSp>
            <p:nvGrpSpPr>
              <p:cNvPr id="191" name="组合 42"/>
              <p:cNvGrpSpPr/>
              <p:nvPr/>
            </p:nvGrpSpPr>
            <p:grpSpPr>
              <a:xfrm>
                <a:off x="-69840" y="4145400"/>
                <a:ext cx="6885000" cy="1186200"/>
                <a:chOff x="-69840" y="4145400"/>
                <a:chExt cx="6885000" cy="1186200"/>
              </a:xfrm>
            </p:grpSpPr>
            <p:grpSp>
              <p:nvGrpSpPr>
                <p:cNvPr id="192" name="组合 15"/>
                <p:cNvGrpSpPr/>
                <p:nvPr/>
              </p:nvGrpSpPr>
              <p:grpSpPr>
                <a:xfrm>
                  <a:off x="-69840" y="4442760"/>
                  <a:ext cx="776520" cy="745920"/>
                  <a:chOff x="-69840" y="4442760"/>
                  <a:chExt cx="776520" cy="745920"/>
                </a:xfrm>
              </p:grpSpPr>
              <p:sp>
                <p:nvSpPr>
                  <p:cNvPr id="193" name="文本框 4"/>
                  <p:cNvSpPr/>
                  <p:nvPr/>
                </p:nvSpPr>
                <p:spPr>
                  <a:xfrm>
                    <a:off x="50760" y="4442760"/>
                    <a:ext cx="61776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Arial"/>
                      </a:rPr>
                      <a:t>ZO-1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194" name="文本框 5"/>
                  <p:cNvSpPr/>
                  <p:nvPr/>
                </p:nvSpPr>
                <p:spPr>
                  <a:xfrm>
                    <a:off x="-69840" y="4881600"/>
                    <a:ext cx="776520" cy="307080"/>
                  </a:xfrm>
                  <a:prstGeom prst="rect">
                    <a:avLst/>
                  </a:prstGeom>
                  <a:noFill/>
                  <a:ln w="0">
                    <a:noFill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spAutoFit/>
                  </a:bodyPr>
                  <a:p>
                    <a:pPr>
                      <a:tabLst>
                        <a:tab algn="l" pos="0"/>
                        <a:tab algn="l" pos="914400"/>
                        <a:tab algn="l" pos="1828800"/>
                        <a:tab algn="l" pos="2743200"/>
                        <a:tab algn="l" pos="3657600"/>
                        <a:tab algn="l" pos="4572000"/>
                        <a:tab algn="l" pos="5486400"/>
                        <a:tab algn="l" pos="6400800"/>
                        <a:tab algn="l" pos="7315200"/>
                        <a:tab algn="l" pos="8229600"/>
                        <a:tab algn="l" pos="9144000"/>
                        <a:tab algn="l" pos="10058400"/>
                      </a:tabLst>
                    </a:pPr>
                    <a:r>
                      <a:rPr b="1" lang="en-US" sz="1400" spc="-1" strike="noStrike">
                        <a:solidFill>
                          <a:srgbClr val="000000"/>
                        </a:solidFill>
                        <a:latin typeface="Arial"/>
                      </a:rPr>
                      <a:t>β-actin</a:t>
                    </a:r>
                    <a:endParaRPr b="0" lang="en-US" sz="14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  <p:grpSp>
              <p:nvGrpSpPr>
                <p:cNvPr id="195" name="组合 41"/>
                <p:cNvGrpSpPr/>
                <p:nvPr/>
              </p:nvGrpSpPr>
              <p:grpSpPr>
                <a:xfrm>
                  <a:off x="587880" y="4145400"/>
                  <a:ext cx="6227280" cy="1186200"/>
                  <a:chOff x="587880" y="4145400"/>
                  <a:chExt cx="6227280" cy="1186200"/>
                </a:xfrm>
              </p:grpSpPr>
              <p:grpSp>
                <p:nvGrpSpPr>
                  <p:cNvPr id="196" name="组合 6"/>
                  <p:cNvGrpSpPr/>
                  <p:nvPr/>
                </p:nvGrpSpPr>
                <p:grpSpPr>
                  <a:xfrm>
                    <a:off x="587880" y="4390200"/>
                    <a:ext cx="4066560" cy="811080"/>
                    <a:chOff x="587880" y="4390200"/>
                    <a:chExt cx="4066560" cy="811080"/>
                  </a:xfrm>
                </p:grpSpPr>
                <p:pic>
                  <p:nvPicPr>
                    <p:cNvPr id="197" name="图片 2" descr="ZO- 1（2）"/>
                    <p:cNvPicPr/>
                    <p:nvPr/>
                  </p:nvPicPr>
                  <p:blipFill>
                    <a:blip r:embed="rId6"/>
                    <a:stretch/>
                  </p:blipFill>
                  <p:spPr>
                    <a:xfrm>
                      <a:off x="588960" y="4390200"/>
                      <a:ext cx="4065480" cy="35388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  <p:pic>
                  <p:nvPicPr>
                    <p:cNvPr id="198" name="图片 4" descr="β- actin（2）"/>
                    <p:cNvPicPr/>
                    <p:nvPr/>
                  </p:nvPicPr>
                  <p:blipFill>
                    <a:blip r:embed="rId7"/>
                    <a:stretch/>
                  </p:blipFill>
                  <p:spPr>
                    <a:xfrm>
                      <a:off x="587880" y="4848840"/>
                      <a:ext cx="4065480" cy="352440"/>
                    </a:xfrm>
                    <a:prstGeom prst="rect">
                      <a:avLst/>
                    </a:prstGeom>
                    <a:ln w="0">
                      <a:noFill/>
                    </a:ln>
                  </p:spPr>
                </p:pic>
              </p:grpSp>
              <p:pic>
                <p:nvPicPr>
                  <p:cNvPr id="199" name="图片 8" descr="ZO-1（2）"/>
                  <p:cNvPicPr/>
                  <p:nvPr/>
                </p:nvPicPr>
                <p:blipFill>
                  <a:blip r:embed="rId8"/>
                  <a:srcRect l="7176" t="21989" r="9596" b="29671"/>
                  <a:stretch/>
                </p:blipFill>
                <p:spPr>
                  <a:xfrm>
                    <a:off x="4852440" y="4185720"/>
                    <a:ext cx="1962720" cy="1145880"/>
                  </a:xfrm>
                  <a:prstGeom prst="rect">
                    <a:avLst/>
                  </a:prstGeom>
                  <a:ln w="0">
                    <a:noFill/>
                  </a:ln>
                </p:spPr>
              </p:pic>
              <p:grpSp>
                <p:nvGrpSpPr>
                  <p:cNvPr id="200" name="组合 29"/>
                  <p:cNvGrpSpPr/>
                  <p:nvPr/>
                </p:nvGrpSpPr>
                <p:grpSpPr>
                  <a:xfrm>
                    <a:off x="597960" y="4145400"/>
                    <a:ext cx="4175280" cy="246240"/>
                    <a:chOff x="597960" y="4145400"/>
                    <a:chExt cx="4175280" cy="246240"/>
                  </a:xfrm>
                </p:grpSpPr>
                <p:grpSp>
                  <p:nvGrpSpPr>
                    <p:cNvPr id="201" name="组合 30"/>
                    <p:cNvGrpSpPr/>
                    <p:nvPr/>
                  </p:nvGrpSpPr>
                  <p:grpSpPr>
                    <a:xfrm>
                      <a:off x="597960" y="4145400"/>
                      <a:ext cx="2189880" cy="246240"/>
                      <a:chOff x="597960" y="4145400"/>
                      <a:chExt cx="2189880" cy="246240"/>
                    </a:xfrm>
                  </p:grpSpPr>
                  <p:sp>
                    <p:nvSpPr>
                      <p:cNvPr id="202" name="文本框 31"/>
                      <p:cNvSpPr/>
                      <p:nvPr/>
                    </p:nvSpPr>
                    <p:spPr>
                      <a:xfrm>
                        <a:off x="597960" y="4145400"/>
                        <a:ext cx="50724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Con3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203" name="文本框 32"/>
                      <p:cNvSpPr/>
                      <p:nvPr/>
                    </p:nvSpPr>
                    <p:spPr>
                      <a:xfrm>
                        <a:off x="1007640" y="4145400"/>
                        <a:ext cx="62604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DKD3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204" name="文本框 33"/>
                      <p:cNvSpPr/>
                      <p:nvPr/>
                    </p:nvSpPr>
                    <p:spPr>
                      <a:xfrm>
                        <a:off x="1397160" y="4145400"/>
                        <a:ext cx="77580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QRXZF3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205" name="文本框 34"/>
                      <p:cNvSpPr/>
                      <p:nvPr/>
                    </p:nvSpPr>
                    <p:spPr>
                      <a:xfrm>
                        <a:off x="1908720" y="4145400"/>
                        <a:ext cx="87912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Irbesartan3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  <p:grpSp>
                  <p:nvGrpSpPr>
                    <p:cNvPr id="206" name="组合 35"/>
                    <p:cNvGrpSpPr/>
                    <p:nvPr/>
                  </p:nvGrpSpPr>
                  <p:grpSpPr>
                    <a:xfrm>
                      <a:off x="2608200" y="4145400"/>
                      <a:ext cx="2165040" cy="246240"/>
                      <a:chOff x="2608200" y="4145400"/>
                      <a:chExt cx="2165040" cy="246240"/>
                    </a:xfrm>
                  </p:grpSpPr>
                  <p:sp>
                    <p:nvSpPr>
                      <p:cNvPr id="207" name="文本框 36"/>
                      <p:cNvSpPr/>
                      <p:nvPr/>
                    </p:nvSpPr>
                    <p:spPr>
                      <a:xfrm>
                        <a:off x="2608200" y="4145400"/>
                        <a:ext cx="54000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Con4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208" name="文本框 37"/>
                      <p:cNvSpPr/>
                      <p:nvPr/>
                    </p:nvSpPr>
                    <p:spPr>
                      <a:xfrm>
                        <a:off x="2991240" y="4145400"/>
                        <a:ext cx="59436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DKD4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209" name="文本框 38"/>
                      <p:cNvSpPr/>
                      <p:nvPr/>
                    </p:nvSpPr>
                    <p:spPr>
                      <a:xfrm>
                        <a:off x="3385440" y="4145400"/>
                        <a:ext cx="76824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QRXZF4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  <p:sp>
                    <p:nvSpPr>
                      <p:cNvPr id="210" name="文本框 39"/>
                      <p:cNvSpPr/>
                      <p:nvPr/>
                    </p:nvSpPr>
                    <p:spPr>
                      <a:xfrm>
                        <a:off x="3938400" y="4145400"/>
                        <a:ext cx="834840" cy="246240"/>
                      </a:xfrm>
                      <a:prstGeom prst="rect">
                        <a:avLst/>
                      </a:prstGeom>
                      <a:noFill/>
                      <a:ln w="0">
                        <a:noFill/>
                      </a:ln>
                    </p:spPr>
                    <p:style>
                      <a:lnRef idx="0"/>
                      <a:fillRef idx="0"/>
                      <a:effectRef idx="0"/>
                      <a:fontRef idx="minor"/>
                    </p:style>
                    <p:txBody>
                      <a:bodyPr lIns="90000" rIns="90000" tIns="46800" bIns="46800" anchor="t">
                        <a:spAutoFit/>
                      </a:bodyPr>
                      <a:p>
                        <a:pPr>
                          <a:tabLst>
                            <a:tab algn="l" pos="0"/>
                            <a:tab algn="l" pos="914400"/>
                            <a:tab algn="l" pos="1828800"/>
                            <a:tab algn="l" pos="2743200"/>
                            <a:tab algn="l" pos="3657600"/>
                            <a:tab algn="l" pos="4572000"/>
                            <a:tab algn="l" pos="5486400"/>
                            <a:tab algn="l" pos="6400800"/>
                            <a:tab algn="l" pos="7315200"/>
                            <a:tab algn="l" pos="8229600"/>
                            <a:tab algn="l" pos="9144000"/>
                            <a:tab algn="l" pos="10058400"/>
                          </a:tabLst>
                        </a:pPr>
                        <a:r>
                          <a:rPr b="0" lang="en-US" sz="1000" spc="-1" strike="noStrike">
                            <a:solidFill>
                              <a:srgbClr val="000000"/>
                            </a:solidFill>
                            <a:latin typeface="Arial"/>
                          </a:rPr>
                          <a:t>Irbesartan4</a:t>
                        </a:r>
                        <a:endParaRPr b="0" lang="en-US" sz="1000" spc="-1" strike="noStrike">
                          <a:solidFill>
                            <a:srgbClr val="000000"/>
                          </a:solidFill>
                          <a:latin typeface="Arial"/>
                        </a:endParaRPr>
                      </a:p>
                    </p:txBody>
                  </p:sp>
                </p:grpSp>
              </p:grpSp>
            </p:grpSp>
          </p:grpSp>
        </p:grpSp>
      </p:grpSp>
      <p:sp>
        <p:nvSpPr>
          <p:cNvPr id="211" name="文本框 45"/>
          <p:cNvSpPr/>
          <p:nvPr/>
        </p:nvSpPr>
        <p:spPr>
          <a:xfrm>
            <a:off x="163440" y="5989680"/>
            <a:ext cx="676440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One important note about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ZO-1 : </a:t>
            </a:r>
            <a:r>
              <a:rPr b="0" lang="zh-CN" sz="1800" spc="-1" strike="noStrike">
                <a:solidFill>
                  <a:srgbClr val="000000"/>
                </a:solidFill>
                <a:latin typeface="Arial"/>
              </a:rPr>
              <a:t>At the beginning of the experiment, we designed irbesartan group. but according to the test results, we did not use the WB results of this group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2" name="文本框 4"/>
          <p:cNvSpPr/>
          <p:nvPr/>
        </p:nvSpPr>
        <p:spPr>
          <a:xfrm>
            <a:off x="2693880" y="4075200"/>
            <a:ext cx="2078280" cy="368280"/>
          </a:xfrm>
          <a:prstGeom prst="rect">
            <a:avLst/>
          </a:prstGeom>
          <a:noFill/>
          <a:ln w="12600">
            <a:solidFill>
              <a:srgbClr val="ff0000"/>
            </a:solidFill>
            <a:round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cxnSp>
        <p:nvCxnSpPr>
          <p:cNvPr id="213" name="直接箭头连接符 6"/>
          <p:cNvCxnSpPr/>
          <p:nvPr/>
        </p:nvCxnSpPr>
        <p:spPr>
          <a:xfrm>
            <a:off x="4771800" y="4186080"/>
            <a:ext cx="378360" cy="5760"/>
          </a:xfrm>
          <a:prstGeom prst="straightConnector1">
            <a:avLst/>
          </a:prstGeom>
          <a:ln w="12600">
            <a:solidFill>
              <a:srgbClr val="ff0000"/>
            </a:solidFill>
            <a:miter/>
            <a:tailEnd len="med" type="arrow" w="med"/>
          </a:ln>
        </p:spPr>
      </p:cxnSp>
      <p:sp>
        <p:nvSpPr>
          <p:cNvPr id="214" name="文本框 7"/>
          <p:cNvSpPr/>
          <p:nvPr/>
        </p:nvSpPr>
        <p:spPr>
          <a:xfrm>
            <a:off x="5099040" y="4075200"/>
            <a:ext cx="189216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zh-CN" sz="1200" spc="-1" strike="noStrike">
                <a:solidFill>
                  <a:srgbClr val="000000"/>
                </a:solidFill>
                <a:latin typeface="Arial"/>
              </a:rPr>
              <a:t>Not included in Statistics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21-04-22T13:50:50Z</dcterms:created>
  <dc:creator>17888808595</dc:creator>
  <dc:description/>
  <dc:language>en-US</dc:language>
  <cp:lastModifiedBy>戒骄戒躁</cp:lastModifiedBy>
  <dcterms:modified xsi:type="dcterms:W3CDTF">2021-06-08T11:29:36Z</dcterms:modified>
  <cp:revision>192</cp:revision>
  <dc:subject/>
  <dc:title/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ICV">
    <vt:lpwstr>973FB2ABDD1245849A1F0DD343DBD888</vt:lpwstr>
  </property>
  <property fmtid="{D5CDD505-2E9C-101B-9397-08002B2CF9AE}" pid="3" name="KSOProductBuildVer">
    <vt:lpwstr>2052-11.1.0.9098</vt:lpwstr>
  </property>
</Properties>
</file>